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1" d="100"/>
          <a:sy n="81" d="100"/>
        </p:scale>
        <p:origin x="-2480" y="-8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5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384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55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4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6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0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0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7" Type="http://schemas.openxmlformats.org/officeDocument/2006/relationships/image" Target="../media/image4.tiff"/><Relationship Id="rId8" Type="http://schemas.openxmlformats.org/officeDocument/2006/relationships/image" Target="../media/image5.tiff"/><Relationship Id="rId9" Type="http://schemas.openxmlformats.org/officeDocument/2006/relationships/image" Target="../media/image6.jpeg"/><Relationship Id="rId10" Type="http://schemas.microsoft.com/office/2007/relationships/hdphoto" Target="../media/hdphoto3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30202" b="48141"/>
          <a:stretch/>
        </p:blipFill>
        <p:spPr>
          <a:xfrm>
            <a:off x="3495484" y="3358202"/>
            <a:ext cx="1735995" cy="128986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609" r="30202" b="40425"/>
          <a:stretch/>
        </p:blipFill>
        <p:spPr>
          <a:xfrm>
            <a:off x="1730434" y="2039259"/>
            <a:ext cx="1735995" cy="1292462"/>
          </a:xfrm>
          <a:prstGeom prst="rect">
            <a:avLst/>
          </a:prstGeom>
        </p:spPr>
      </p:pic>
      <p:sp>
        <p:nvSpPr>
          <p:cNvPr id="29" name="Rectangle 38"/>
          <p:cNvSpPr>
            <a:spLocks noChangeArrowheads="1"/>
          </p:cNvSpPr>
          <p:nvPr/>
        </p:nvSpPr>
        <p:spPr bwMode="auto">
          <a:xfrm>
            <a:off x="349274" y="381000"/>
            <a:ext cx="74396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S5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Figure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393981" y="501088"/>
            <a:ext cx="131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645141" y="501088"/>
            <a:ext cx="952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 signal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9274" y="728797"/>
            <a:ext cx="1450487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HK/38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 control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y anti-DST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49274" y="2041908"/>
            <a:ext cx="13823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HK/38 +Dox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 control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y anti-IL-38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49274" y="3349896"/>
            <a:ext cx="11297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HK/38 +Dox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 control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 first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4715301" y="4375493"/>
            <a:ext cx="5744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Straight Connector 176"/>
          <p:cNvCxnSpPr/>
          <p:nvPr/>
        </p:nvCxnSpPr>
        <p:spPr>
          <a:xfrm>
            <a:off x="1946244" y="404043"/>
            <a:ext cx="180045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" r="30202" b="48140"/>
          <a:stretch/>
        </p:blipFill>
        <p:spPr>
          <a:xfrm>
            <a:off x="1730434" y="3358203"/>
            <a:ext cx="1735995" cy="12898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63" r="30202" b="40346"/>
          <a:stretch/>
        </p:blipFill>
        <p:spPr>
          <a:xfrm>
            <a:off x="3495484" y="2043595"/>
            <a:ext cx="1735995" cy="128812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78" r="30202" b="39156"/>
          <a:stretch/>
        </p:blipFill>
        <p:spPr>
          <a:xfrm>
            <a:off x="3495484" y="718148"/>
            <a:ext cx="1735995" cy="129246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133" r="30202" b="39076"/>
          <a:stretch/>
        </p:blipFill>
        <p:spPr>
          <a:xfrm>
            <a:off x="1730434" y="722483"/>
            <a:ext cx="1735995" cy="1288128"/>
          </a:xfrm>
          <a:prstGeom prst="rect">
            <a:avLst/>
          </a:prstGeom>
        </p:spPr>
      </p:pic>
      <p:cxnSp>
        <p:nvCxnSpPr>
          <p:cNvPr id="66" name="Straight Connector 65"/>
          <p:cNvCxnSpPr/>
          <p:nvPr/>
        </p:nvCxnSpPr>
        <p:spPr>
          <a:xfrm>
            <a:off x="4905915" y="4602158"/>
            <a:ext cx="270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206271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46</Words>
  <Application>Microsoft Macintosh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ept. de Pathologi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y Palmer</dc:creator>
  <cp:lastModifiedBy>Gaby Palmer</cp:lastModifiedBy>
  <cp:revision>79</cp:revision>
  <dcterms:created xsi:type="dcterms:W3CDTF">2019-06-06T13:32:21Z</dcterms:created>
  <dcterms:modified xsi:type="dcterms:W3CDTF">2019-10-10T11:54:09Z</dcterms:modified>
</cp:coreProperties>
</file>